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2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27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67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93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568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3186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596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88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206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34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77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0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257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B826489-2770-4A4C-9270-99342AAE31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7643803"/>
              </p:ext>
            </p:extLst>
          </p:nvPr>
        </p:nvGraphicFramePr>
        <p:xfrm>
          <a:off x="953965" y="644769"/>
          <a:ext cx="4950070" cy="54738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18492">
                  <a:extLst>
                    <a:ext uri="{9D8B030D-6E8A-4147-A177-3AD203B41FA5}">
                      <a16:colId xmlns:a16="http://schemas.microsoft.com/office/drawing/2014/main" val="3755660372"/>
                    </a:ext>
                  </a:extLst>
                </a:gridCol>
                <a:gridCol w="3531578">
                  <a:extLst>
                    <a:ext uri="{9D8B030D-6E8A-4147-A177-3AD203B41FA5}">
                      <a16:colId xmlns:a16="http://schemas.microsoft.com/office/drawing/2014/main" val="256972532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84579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FF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: CCAGAAGGCAGAGGGTTGTAGTGA</a:t>
                      </a:r>
                      <a:endParaRPr lang="ko-KR" alt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altLang="ko-KR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: AGGAGCCGGGCAATATTTTTTA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6542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FG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: GTGGACAGGAAGCAGCTCA</a:t>
                      </a:r>
                      <a:endParaRPr lang="ko-KR" alt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altLang="ko-KR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: TATTGGGGGTCGTCATAACC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49599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FK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GGAACGAGGAGGTCTTTTG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GCACCCCCTCTCCCTAGA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1766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F1A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: CCCCAGATTCAGGATCAGACA</a:t>
                      </a:r>
                      <a:endParaRPr lang="ko-KR" alt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altLang="ko-KR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: GGACTATTAGGCTCAGGTGAACTTTG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280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NT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CAACCCCGAAATGACAT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: GCCGCTTAATAGCCCTCTG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21582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1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GGACAGGGAAGGGTTAAAG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TCAGCACGACCAGGAC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84090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P4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GGCTGGAATGACTGGATTGT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TGGTTGAGTTGAGGTGGTCA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0582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B2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CCTGTAGCCCCATAAC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: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CAAGTAGCTGATCCCAAA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3561629"/>
                  </a:ext>
                </a:extLst>
              </a:tr>
              <a:tr h="46892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C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</a:t>
                      </a:r>
                      <a:r>
                        <a:rPr lang="en-US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TTGCTGTAGAGGTCGTCA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: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AACCTCAGACACGGCTA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355236"/>
                  </a:ext>
                </a:extLst>
              </a:tr>
              <a:tr h="38725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1A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GTGGCCCAGAAGAACTGGTA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GCCATACTCGAACTGGAAT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2902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H1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GGCTGATGGAGAGCTGAACATT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AGCAGTGTAGGCAAACTGAATTAAA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01868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FE2L2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AGTGGATCTGCCAACTACT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ATCTACAAACGGGAATGTC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01536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s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 GAGGATGAGGTGGAACGTGT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AGAAGTGACGCAGCCCTCTA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198908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202D58E-CE6A-452D-A6F8-B106F7405B94}"/>
              </a:ext>
            </a:extLst>
          </p:cNvPr>
          <p:cNvSpPr txBox="1"/>
          <p:nvPr/>
        </p:nvSpPr>
        <p:spPr>
          <a:xfrm>
            <a:off x="1" y="211014"/>
            <a:ext cx="6775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4. Primers for qPCR</a:t>
            </a:r>
          </a:p>
        </p:txBody>
      </p:sp>
    </p:spTree>
    <p:extLst>
      <p:ext uri="{BB962C8B-B14F-4D97-AF65-F5344CB8AC3E}">
        <p14:creationId xmlns:p14="http://schemas.microsoft.com/office/powerpoint/2010/main" val="1919926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</TotalTime>
  <Words>100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jung Moon</dc:creator>
  <cp:lastModifiedBy>Moon Ejung</cp:lastModifiedBy>
  <cp:revision>24</cp:revision>
  <cp:lastPrinted>2018-12-27T23:59:30Z</cp:lastPrinted>
  <dcterms:created xsi:type="dcterms:W3CDTF">2018-12-27T23:58:40Z</dcterms:created>
  <dcterms:modified xsi:type="dcterms:W3CDTF">2021-05-20T15:24:22Z</dcterms:modified>
</cp:coreProperties>
</file>